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84B1880-D039-4351-9AB1-438CC0EC39D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0439A05-071C-4E84-B7BD-DD469CC5097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04A4FDB-6AD5-41B7-B5FB-4E23AE3FBC7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DBA754B-2606-4790-9B0A-C2C8D489F60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7ABB87D-4A32-4F69-9260-20007C373BD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7120A68-BB84-45D6-B15C-4D277C27E4C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DA1F951-EFFE-402B-BF6C-BFD4FCBA6B5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E0E8C70-7B46-45FD-9F15-BE973324E89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8960788-32BD-4439-A281-08B09E7E717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E879D34-D3F6-4A51-8651-097CCA673E9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47CBD28-ADFB-433F-8FB3-127EE94C7DD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589C3F3-326C-49CC-9C6A-3ED10E3663D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511DFD6-16AA-4694-BFEA-7C0523F96EC2}" type="slidenum">
              <a:rPr b="0" lang="zh-CN"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7"/>
          <p:cNvSpPr/>
          <p:nvPr/>
        </p:nvSpPr>
        <p:spPr>
          <a:xfrm>
            <a:off x="1569960" y="2666880"/>
            <a:ext cx="2714760" cy="1007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Figure S6. The percentage differences of amino acid sites in deduced proteins of the LKs in 11 subgroups. The sequences in each subgroup were aligned using the ClustalX program, and sequence differences were calculated using the MEGA4 program. </a:t>
            </a:r>
            <a:endParaRPr b="0" lang="en-US" sz="1000" spc="-1" strike="noStrike">
              <a:solidFill>
                <a:srgbClr val="000000"/>
              </a:solidFill>
              <a:latin typeface="Calibri"/>
            </a:endParaRPr>
          </a:p>
        </p:txBody>
      </p:sp>
      <p:grpSp>
        <p:nvGrpSpPr>
          <p:cNvPr id="42" name="Group 4"/>
          <p:cNvGrpSpPr/>
          <p:nvPr/>
        </p:nvGrpSpPr>
        <p:grpSpPr>
          <a:xfrm>
            <a:off x="1565280" y="595440"/>
            <a:ext cx="2508120" cy="1960920"/>
            <a:chOff x="1565280" y="595440"/>
            <a:chExt cx="2508120" cy="1960920"/>
          </a:xfrm>
        </p:grpSpPr>
        <p:sp>
          <p:nvSpPr>
            <p:cNvPr id="43" name="TextBox 6"/>
            <p:cNvSpPr/>
            <p:nvPr/>
          </p:nvSpPr>
          <p:spPr>
            <a:xfrm>
              <a:off x="2570400" y="2310120"/>
              <a:ext cx="7858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Subgroups</a:t>
              </a:r>
              <a:endParaRPr b="0" lang="en-US" sz="1000" spc="-1" strike="noStrike">
                <a:solidFill>
                  <a:srgbClr val="000000"/>
                </a:solidFill>
                <a:latin typeface="Calibri"/>
              </a:endParaRPr>
            </a:p>
          </p:txBody>
        </p:sp>
        <p:pic>
          <p:nvPicPr>
            <p:cNvPr id="44" name="图表 1" descr=""/>
            <p:cNvPicPr/>
            <p:nvPr/>
          </p:nvPicPr>
          <p:blipFill>
            <a:blip r:embed="rId1"/>
            <a:stretch/>
          </p:blipFill>
          <p:spPr>
            <a:xfrm>
              <a:off x="1780560" y="597240"/>
              <a:ext cx="2292840" cy="1834920"/>
            </a:xfrm>
            <a:prstGeom prst="rect">
              <a:avLst/>
            </a:prstGeom>
            <a:ln w="0">
              <a:noFill/>
            </a:ln>
          </p:spPr>
        </p:pic>
        <p:sp>
          <p:nvSpPr>
            <p:cNvPr id="45" name="TextBox 2"/>
            <p:cNvSpPr/>
            <p:nvPr/>
          </p:nvSpPr>
          <p:spPr>
            <a:xfrm rot="16200000">
              <a:off x="859680" y="1301040"/>
              <a:ext cx="16574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ercentage of different sites</a:t>
              </a:r>
              <a:endParaRPr b="0" lang="en-US" sz="10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12-16T01:17:56Z</dcterms:created>
  <dc:creator>xl</dc:creator>
  <dc:description/>
  <dc:language>en-US</dc:language>
  <cp:lastModifiedBy>xl</cp:lastModifiedBy>
  <dcterms:modified xsi:type="dcterms:W3CDTF">2010-12-16T01:20:14Z</dcterms:modified>
  <cp:revision>1</cp:revision>
  <dc:subject/>
  <dc:title>PowerPoint Presentation</dc:title>
</cp:coreProperties>
</file>